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60EC-08FB-F445-8CA6-B0576C1C5F80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9C044-67D5-2E4D-A3A1-9D47CB99757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67213" y="218339"/>
            <a:ext cx="8323507" cy="1105917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Supplementary Figure 11:</a:t>
            </a:r>
            <a:br>
              <a:rPr lang="en-US" sz="2400" dirty="0"/>
            </a:br>
            <a:r>
              <a:rPr lang="en-US" sz="2333" dirty="0"/>
              <a:t>Use of Cell Profiler software in the counting of crystal violet-stained cells</a:t>
            </a:r>
          </a:p>
        </p:txBody>
      </p:sp>
      <p:pic>
        <p:nvPicPr>
          <p:cNvPr id="4" name="Picture 3" descr="2016-05-1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8253" y="1324256"/>
            <a:ext cx="6083301" cy="544195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Supplementary Figure 11: Use of Cell Profiler software in the counting of crystal violet-stained cells</vt:lpstr>
    </vt:vector>
  </TitlesOfParts>
  <Company>Wayne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X: Use of Cell Profiler software in the counting of crystal violet-stained cells</dc:title>
  <dc:creator>Anton-Scott Goustin</dc:creator>
  <cp:lastModifiedBy>Erica</cp:lastModifiedBy>
  <cp:revision>5</cp:revision>
  <dcterms:created xsi:type="dcterms:W3CDTF">2016-05-24T00:50:38Z</dcterms:created>
  <dcterms:modified xsi:type="dcterms:W3CDTF">2016-11-20T06:16:22Z</dcterms:modified>
</cp:coreProperties>
</file>